
<file path=[Content_Types].xml><?xml version="1.0" encoding="utf-8"?>
<Types xmlns="http://schemas.openxmlformats.org/package/2006/content-types">
  <Default Extension="fntdata" ContentType="application/x-fontdata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</p:sldMasterIdLst>
  <p:notesMasterIdLst>
    <p:notesMasterId r:id="rId8"/>
  </p:notesMasterIdLst>
  <p:sldIdLst>
    <p:sldId id="267" r:id="rId2"/>
    <p:sldId id="268" r:id="rId3"/>
    <p:sldId id="270" r:id="rId4"/>
    <p:sldId id="269" r:id="rId5"/>
    <p:sldId id="271" r:id="rId6"/>
    <p:sldId id="272" r:id="rId7"/>
  </p:sldIdLst>
  <p:sldSz cx="12192000" cy="6858000"/>
  <p:notesSz cx="6858000" cy="9144000"/>
  <p:embeddedFontLst>
    <p:embeddedFont>
      <p:font typeface="Play" pitchFamily="82" charset="77"/>
      <p:regular r:id="rId9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3552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  <p:ext uri="GoogleSlidesCustomDataVersion2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12" roundtripDataSignature="AMtx7mgjJlh9TGkzln1xy7fGlYhoeJJtUQ==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632A6217-4B7F-97CB-4CFD-AB25AFA0BC0B}" name="Musarrat Nahid" initials="MN" userId="S::mun4003@med.cornell.edu::1d0239c2-ca6e-4cc2-bf23-67d78d26bb4d" providerId="AD"/>
  <p188:author id="{60288940-85F5-CD02-5FCA-7C6BF1BBFDE6}" name="omar zainul" initials="oz" userId="603f6a1bd9498895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9687"/>
    <p:restoredTop sz="89726"/>
  </p:normalViewPr>
  <p:slideViewPr>
    <p:cSldViewPr snapToGrid="0">
      <p:cViewPr varScale="1">
        <p:scale>
          <a:sx n="109" d="100"/>
          <a:sy n="109" d="100"/>
        </p:scale>
        <p:origin x="864" y="184"/>
      </p:cViewPr>
      <p:guideLst>
        <p:guide orient="horz" pos="3552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customschemas.google.com/relationships/presentationmetadata" Target="metadata"/><Relationship Id="rId17" Type="http://schemas.microsoft.com/office/2018/10/relationships/authors" Target="authors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font" Target="fonts/font1.fntdata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6611B42-855C-FAC8-75E8-2AC52D6F889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261DD448-12B4-753C-BB7B-9E49299E0638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238B2522-E0BC-977B-F8F3-CD1EF032F133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3CE34F5-BCCD-8A9C-0ED3-6044DB3AC21B}"/>
              </a:ext>
            </a:extLst>
          </p:cNvPr>
          <p:cNvSpPr>
            <a:spLocks noGrp="1"/>
          </p:cNvSpPr>
          <p:nvPr>
            <p:ph type="sldNum" idx="12"/>
          </p:nvPr>
        </p:nvSpPr>
        <p:spPr/>
        <p:txBody>
          <a:bodyPr/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 smtClean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1</a:t>
            </a:fld>
            <a:endParaRPr lang="en-US" sz="12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65070932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563537F-6F8C-6384-E359-ACD41293633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E82429CD-16EF-FBE9-1B96-4E8F352A1D8E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C2C424A5-364F-3D9D-570C-49FAA55BD606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0E666AA-3B5A-2670-655B-AE5BA4F90796}"/>
              </a:ext>
            </a:extLst>
          </p:cNvPr>
          <p:cNvSpPr>
            <a:spLocks noGrp="1"/>
          </p:cNvSpPr>
          <p:nvPr>
            <p:ph type="sldNum" idx="12"/>
          </p:nvPr>
        </p:nvSpPr>
        <p:spPr/>
        <p:txBody>
          <a:bodyPr/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 smtClean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2</a:t>
            </a:fld>
            <a:endParaRPr lang="en-US" sz="12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43062560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D876B24-63DE-A236-1259-AE1D51B2229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9BDA1B06-EFC7-3B79-4598-70A5CDD7CCBA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210376D3-2C56-944E-A6C7-7D8998968B4B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0B6697B-0523-D035-9E8D-4401AB014FD4}"/>
              </a:ext>
            </a:extLst>
          </p:cNvPr>
          <p:cNvSpPr>
            <a:spLocks noGrp="1"/>
          </p:cNvSpPr>
          <p:nvPr>
            <p:ph type="sldNum" idx="12"/>
          </p:nvPr>
        </p:nvSpPr>
        <p:spPr/>
        <p:txBody>
          <a:bodyPr/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 smtClean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3</a:t>
            </a:fld>
            <a:endParaRPr lang="en-US" sz="12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84626677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2498D1E-0BB1-6286-BD01-6987D47D244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7C25970C-69E8-4601-417D-2DE1826BCFE9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2213E9C8-3D42-0ECF-2156-7E5A67FEF964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7359ED5-A605-6ECD-4960-8BDF4FC13132}"/>
              </a:ext>
            </a:extLst>
          </p:cNvPr>
          <p:cNvSpPr>
            <a:spLocks noGrp="1"/>
          </p:cNvSpPr>
          <p:nvPr>
            <p:ph type="sldNum" idx="12"/>
          </p:nvPr>
        </p:nvSpPr>
        <p:spPr/>
        <p:txBody>
          <a:bodyPr/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 smtClean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4</a:t>
            </a:fld>
            <a:endParaRPr lang="en-US" sz="12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44462329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7095D59-B52B-C63E-6935-E25ADF8C8D4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4665FFAA-89B0-71C0-EAF6-4D56B779ABA2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4B447101-BD3B-A8BE-B7BE-B5EEFE5A51B6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D2B2ACE-0B34-89DE-891B-36EDF262CAEE}"/>
              </a:ext>
            </a:extLst>
          </p:cNvPr>
          <p:cNvSpPr>
            <a:spLocks noGrp="1"/>
          </p:cNvSpPr>
          <p:nvPr>
            <p:ph type="sldNum" idx="12"/>
          </p:nvPr>
        </p:nvSpPr>
        <p:spPr/>
        <p:txBody>
          <a:bodyPr/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 smtClean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5</a:t>
            </a:fld>
            <a:endParaRPr lang="en-US" sz="12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7842470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AA4C784-E13B-6E92-9CD4-9C5A5C37381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04ED26BD-DC36-4083-A162-EE8EC99A8751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EB7FCBAC-ABBA-BF3D-280B-9387E0AEB54D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E42C3DD-6CE8-F715-77E1-B534A4D5CD54}"/>
              </a:ext>
            </a:extLst>
          </p:cNvPr>
          <p:cNvSpPr>
            <a:spLocks noGrp="1"/>
          </p:cNvSpPr>
          <p:nvPr>
            <p:ph type="sldNum" idx="12"/>
          </p:nvPr>
        </p:nvSpPr>
        <p:spPr/>
        <p:txBody>
          <a:bodyPr/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 smtClean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6</a:t>
            </a:fld>
            <a:endParaRPr lang="en-US" sz="12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0409696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Google Shape;20;p6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Play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6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22" name="Google Shape;22;p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5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5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7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7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8" name="Google Shape;28;p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0" name="Google Shape;30;p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8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Play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8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757575"/>
              </a:buClr>
              <a:buSzPts val="2400"/>
              <a:buNone/>
              <a:defRPr sz="2400">
                <a:solidFill>
                  <a:srgbClr val="757575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2000"/>
              <a:buNone/>
              <a:defRPr sz="2000">
                <a:solidFill>
                  <a:srgbClr val="757575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800"/>
              <a:buNone/>
              <a:defRPr sz="1800">
                <a:solidFill>
                  <a:srgbClr val="757575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600"/>
              <a:buNone/>
              <a:defRPr sz="1600">
                <a:solidFill>
                  <a:srgbClr val="757575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600"/>
              <a:buNone/>
              <a:defRPr sz="1600">
                <a:solidFill>
                  <a:srgbClr val="757575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600"/>
              <a:buNone/>
              <a:defRPr sz="1600">
                <a:solidFill>
                  <a:srgbClr val="757575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600"/>
              <a:buNone/>
              <a:defRPr sz="1600">
                <a:solidFill>
                  <a:srgbClr val="757575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600"/>
              <a:buNone/>
              <a:defRPr sz="1600">
                <a:solidFill>
                  <a:srgbClr val="757575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757575"/>
              </a:buClr>
              <a:buSzPts val="1600"/>
              <a:buNone/>
              <a:defRPr sz="1600">
                <a:solidFill>
                  <a:srgbClr val="757575"/>
                </a:solidFill>
              </a:defRPr>
            </a:lvl9pPr>
          </a:lstStyle>
          <a:p>
            <a:endParaRPr/>
          </a:p>
        </p:txBody>
      </p:sp>
      <p:sp>
        <p:nvSpPr>
          <p:cNvPr id="34" name="Google Shape;34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9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9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1" name="Google Shape;41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0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10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7" name="Google Shape;47;p10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8" name="Google Shape;48;p10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9" name="Google Shape;49;p10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0" name="Google Shape;50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1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2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Play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2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61" name="Google Shape;61;p12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2" name="Google Shape;62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3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Play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3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13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9" name="Google Shape;69;p1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4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4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4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Play"/>
              <a:buNone/>
              <a:defRPr sz="4400" b="0" i="0" u="none" strike="noStrike" cap="none">
                <a:solidFill>
                  <a:schemeClr val="dk1"/>
                </a:solidFill>
                <a:latin typeface="Play"/>
                <a:ea typeface="Play"/>
                <a:cs typeface="Play"/>
                <a:sym typeface="Play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1" name="Google Shape;11;p4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2" name="Google Shape;12;p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3" name="Google Shape;13;p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4" name="Google Shape;14;p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B9D837E-7EFA-D08C-C9F4-4D1D25ED6F6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Google Shape;121;p3">
            <a:extLst>
              <a:ext uri="{FF2B5EF4-FFF2-40B4-BE49-F238E27FC236}">
                <a16:creationId xmlns:a16="http://schemas.microsoft.com/office/drawing/2014/main" id="{7EC685E1-4DAA-ECBE-19A8-3A8EC7C59946}"/>
              </a:ext>
            </a:extLst>
          </p:cNvPr>
          <p:cNvSpPr txBox="1"/>
          <p:nvPr/>
        </p:nvSpPr>
        <p:spPr>
          <a:xfrm>
            <a:off x="204959" y="6234753"/>
            <a:ext cx="10825714" cy="4616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Arial"/>
              </a:rPr>
              <a:t>Supplemental Figure 1: Scatter plot of KCCQ-12 and LSA</a:t>
            </a:r>
          </a:p>
          <a:p>
            <a:pPr lvl="0"/>
            <a:r>
              <a:rPr lang="en-US" sz="1200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: KCCQ-12: 12-item Kansas City Cardiomyopathy Questionnaire; LSA: Life-Space Assessment</a:t>
            </a:r>
            <a:endParaRPr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2F375E70-6D47-A099-81C1-A8800E0F42CD}"/>
              </a:ext>
            </a:extLst>
          </p:cNvPr>
          <p:cNvSpPr/>
          <p:nvPr/>
        </p:nvSpPr>
        <p:spPr>
          <a:xfrm>
            <a:off x="8607498" y="5065986"/>
            <a:ext cx="1051509" cy="16816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B83C583A-218E-3950-B4EA-73B2ABF80E1F}"/>
              </a:ext>
            </a:extLst>
          </p:cNvPr>
          <p:cNvSpPr/>
          <p:nvPr/>
        </p:nvSpPr>
        <p:spPr>
          <a:xfrm>
            <a:off x="8755117" y="5234152"/>
            <a:ext cx="662152" cy="7041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75AE64F-D9D4-8A78-49B8-1266191A87A4}"/>
              </a:ext>
            </a:extLst>
          </p:cNvPr>
          <p:cNvSpPr txBox="1"/>
          <p:nvPr/>
        </p:nvSpPr>
        <p:spPr>
          <a:xfrm>
            <a:off x="8489514" y="4750511"/>
            <a:ext cx="555250" cy="20916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 descr="A graph with red dots&#10;&#10;AI-generated content may be incorrect.">
            <a:extLst>
              <a:ext uri="{FF2B5EF4-FFF2-40B4-BE49-F238E27FC236}">
                <a16:creationId xmlns:a16="http://schemas.microsoft.com/office/drawing/2014/main" id="{2528F593-C402-BB1A-9CDE-7D83AD0DDF1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72000" y="389240"/>
            <a:ext cx="10035934" cy="58455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872003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577402E-01DC-04EF-5DC1-5D3384DC496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Google Shape;121;p3">
            <a:extLst>
              <a:ext uri="{FF2B5EF4-FFF2-40B4-BE49-F238E27FC236}">
                <a16:creationId xmlns:a16="http://schemas.microsoft.com/office/drawing/2014/main" id="{37B117B6-BD16-1C4D-EC02-B51274D7D1E2}"/>
              </a:ext>
            </a:extLst>
          </p:cNvPr>
          <p:cNvSpPr txBox="1"/>
          <p:nvPr/>
        </p:nvSpPr>
        <p:spPr>
          <a:xfrm>
            <a:off x="204959" y="6234753"/>
            <a:ext cx="10825714" cy="4616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Arial"/>
              </a:rPr>
              <a:t>Supplemental Figure 2: Scatter plot of EQ-5D-5L and LSA</a:t>
            </a:r>
          </a:p>
          <a:p>
            <a:pPr lvl="0"/>
            <a:r>
              <a:rPr lang="en-US" sz="1200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: EQ-5D-5L: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uropean Quality of Life 5 Dimensions 5 Level</a:t>
            </a:r>
            <a:r>
              <a:rPr lang="en-US" sz="1200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; LSA: Life-Space Assessment</a:t>
            </a:r>
            <a:endParaRPr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C5CDE3EF-ED34-4A40-36FF-E2CB665CCDFE}"/>
              </a:ext>
            </a:extLst>
          </p:cNvPr>
          <p:cNvSpPr/>
          <p:nvPr/>
        </p:nvSpPr>
        <p:spPr>
          <a:xfrm>
            <a:off x="8607498" y="5065986"/>
            <a:ext cx="1051509" cy="16816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16E04A0A-17FB-A738-C1AC-839D74E5BB2F}"/>
              </a:ext>
            </a:extLst>
          </p:cNvPr>
          <p:cNvSpPr/>
          <p:nvPr/>
        </p:nvSpPr>
        <p:spPr>
          <a:xfrm>
            <a:off x="8755117" y="5234152"/>
            <a:ext cx="662152" cy="7041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F31A374-BA45-CEEA-2ECF-97EB98B8EB8D}"/>
              </a:ext>
            </a:extLst>
          </p:cNvPr>
          <p:cNvSpPr txBox="1"/>
          <p:nvPr/>
        </p:nvSpPr>
        <p:spPr>
          <a:xfrm>
            <a:off x="8489514" y="4750511"/>
            <a:ext cx="555250" cy="20916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 descr="A graph with red dots&#10;&#10;AI-generated content may be incorrect.">
            <a:extLst>
              <a:ext uri="{FF2B5EF4-FFF2-40B4-BE49-F238E27FC236}">
                <a16:creationId xmlns:a16="http://schemas.microsoft.com/office/drawing/2014/main" id="{6AE2105A-A3E3-89F4-11C7-2E93C5B16F2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65042" y="291290"/>
            <a:ext cx="10165631" cy="59434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716159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0B1D1C0-13D4-202C-A086-743BD567AC4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Google Shape;121;p3">
            <a:extLst>
              <a:ext uri="{FF2B5EF4-FFF2-40B4-BE49-F238E27FC236}">
                <a16:creationId xmlns:a16="http://schemas.microsoft.com/office/drawing/2014/main" id="{435C07DF-1BDB-77B3-3CEF-EBDD96C16511}"/>
              </a:ext>
            </a:extLst>
          </p:cNvPr>
          <p:cNvSpPr txBox="1"/>
          <p:nvPr/>
        </p:nvSpPr>
        <p:spPr>
          <a:xfrm>
            <a:off x="204959" y="6234753"/>
            <a:ext cx="10825714" cy="4616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Arial"/>
              </a:rPr>
              <a:t>Supplemental Figure 3: Boxplot of KCCQ-12 and simplified LSA</a:t>
            </a:r>
          </a:p>
          <a:p>
            <a:pPr lvl="0"/>
            <a:r>
              <a:rPr lang="en-US" sz="1200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: KCCQ-12: 12-item Kansas City Cardiomyopathy Questionnaire; LSA: Life-Space Assessment</a:t>
            </a:r>
            <a:endParaRPr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9BE88FDB-7A40-4F50-B558-5A96E215DEAF}"/>
              </a:ext>
            </a:extLst>
          </p:cNvPr>
          <p:cNvSpPr/>
          <p:nvPr/>
        </p:nvSpPr>
        <p:spPr>
          <a:xfrm>
            <a:off x="8607498" y="5065986"/>
            <a:ext cx="1051509" cy="16816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23C6A30B-CF83-6D74-E65F-DF67945087EC}"/>
              </a:ext>
            </a:extLst>
          </p:cNvPr>
          <p:cNvSpPr/>
          <p:nvPr/>
        </p:nvSpPr>
        <p:spPr>
          <a:xfrm>
            <a:off x="8755117" y="5234152"/>
            <a:ext cx="662152" cy="7041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124EE04-AC7B-95A2-F9D6-D45F4E68B2F2}"/>
              </a:ext>
            </a:extLst>
          </p:cNvPr>
          <p:cNvSpPr txBox="1"/>
          <p:nvPr/>
        </p:nvSpPr>
        <p:spPr>
          <a:xfrm>
            <a:off x="8489514" y="4750511"/>
            <a:ext cx="555250" cy="20916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 descr="A graph of a graph&#10;&#10;AI-generated content may be incorrect.">
            <a:extLst>
              <a:ext uri="{FF2B5EF4-FFF2-40B4-BE49-F238E27FC236}">
                <a16:creationId xmlns:a16="http://schemas.microsoft.com/office/drawing/2014/main" id="{0B7A9808-A53C-10A1-2D3D-47FF300BB47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2707" y="63228"/>
            <a:ext cx="10825714" cy="608946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621C63A-261C-6426-6F94-F32F87436A63}"/>
              </a:ext>
            </a:extLst>
          </p:cNvPr>
          <p:cNvSpPr txBox="1"/>
          <p:nvPr/>
        </p:nvSpPr>
        <p:spPr>
          <a:xfrm>
            <a:off x="5844642" y="6055223"/>
            <a:ext cx="15278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implified LSA</a:t>
            </a:r>
          </a:p>
        </p:txBody>
      </p:sp>
    </p:spTree>
    <p:extLst>
      <p:ext uri="{BB962C8B-B14F-4D97-AF65-F5344CB8AC3E}">
        <p14:creationId xmlns:p14="http://schemas.microsoft.com/office/powerpoint/2010/main" val="23848962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6C701A1-7E29-41D8-A179-A2E392BE749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Google Shape;121;p3">
            <a:extLst>
              <a:ext uri="{FF2B5EF4-FFF2-40B4-BE49-F238E27FC236}">
                <a16:creationId xmlns:a16="http://schemas.microsoft.com/office/drawing/2014/main" id="{D297037C-837A-C1FB-9FC2-7B25B18BA172}"/>
              </a:ext>
            </a:extLst>
          </p:cNvPr>
          <p:cNvSpPr txBox="1"/>
          <p:nvPr/>
        </p:nvSpPr>
        <p:spPr>
          <a:xfrm>
            <a:off x="204959" y="6234753"/>
            <a:ext cx="10825714" cy="4616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Arial"/>
              </a:rPr>
              <a:t>Supplemental Figure </a:t>
            </a:r>
            <a:r>
              <a:rPr lang="en-US" sz="1200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sz="1200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Arial"/>
              </a:rPr>
              <a:t>: Boxplot of EQ-5D-5L and simplified LSA</a:t>
            </a:r>
          </a:p>
          <a:p>
            <a:pPr lvl="0"/>
            <a:r>
              <a:rPr lang="en-US" sz="1200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: EQ-5D-5L: 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uropean Quality of Life 5 Dimensions 5 Level</a:t>
            </a:r>
            <a:r>
              <a:rPr lang="en-US" sz="1200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; LSA: Life-Space Assessment</a:t>
            </a:r>
            <a:endParaRPr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BC5811FB-FBF3-CC11-8540-6F03D643743F}"/>
              </a:ext>
            </a:extLst>
          </p:cNvPr>
          <p:cNvSpPr/>
          <p:nvPr/>
        </p:nvSpPr>
        <p:spPr>
          <a:xfrm>
            <a:off x="8607498" y="5065986"/>
            <a:ext cx="1051509" cy="16816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20223AD0-DA0B-12F4-D9E2-1D351B651EE4}"/>
              </a:ext>
            </a:extLst>
          </p:cNvPr>
          <p:cNvSpPr/>
          <p:nvPr/>
        </p:nvSpPr>
        <p:spPr>
          <a:xfrm>
            <a:off x="8755117" y="5234152"/>
            <a:ext cx="662152" cy="7041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D64E2C8-E112-F499-10C9-E7E8FF91C72D}"/>
              </a:ext>
            </a:extLst>
          </p:cNvPr>
          <p:cNvSpPr txBox="1"/>
          <p:nvPr/>
        </p:nvSpPr>
        <p:spPr>
          <a:xfrm>
            <a:off x="8489514" y="4750511"/>
            <a:ext cx="555250" cy="20916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 descr="A graph of a graph&#10;&#10;AI-generated content may be incorrect.">
            <a:extLst>
              <a:ext uri="{FF2B5EF4-FFF2-40B4-BE49-F238E27FC236}">
                <a16:creationId xmlns:a16="http://schemas.microsoft.com/office/drawing/2014/main" id="{403D46C2-E72C-7C11-7857-1C38220E8B4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9260" y="56116"/>
            <a:ext cx="10825714" cy="608065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8372388-B743-9C65-A93C-67BA84A19468}"/>
              </a:ext>
            </a:extLst>
          </p:cNvPr>
          <p:cNvSpPr txBox="1"/>
          <p:nvPr/>
        </p:nvSpPr>
        <p:spPr>
          <a:xfrm>
            <a:off x="5844642" y="6055223"/>
            <a:ext cx="15278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implified LSA</a:t>
            </a:r>
          </a:p>
        </p:txBody>
      </p:sp>
    </p:spTree>
    <p:extLst>
      <p:ext uri="{BB962C8B-B14F-4D97-AF65-F5344CB8AC3E}">
        <p14:creationId xmlns:p14="http://schemas.microsoft.com/office/powerpoint/2010/main" val="401461586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4550171-1917-63AA-07F4-BBC0FD9CF5B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Google Shape;121;p3">
            <a:extLst>
              <a:ext uri="{FF2B5EF4-FFF2-40B4-BE49-F238E27FC236}">
                <a16:creationId xmlns:a16="http://schemas.microsoft.com/office/drawing/2014/main" id="{0A8B9FEC-126E-5DDE-E384-A382FA8CDAB6}"/>
              </a:ext>
            </a:extLst>
          </p:cNvPr>
          <p:cNvSpPr txBox="1"/>
          <p:nvPr/>
        </p:nvSpPr>
        <p:spPr>
          <a:xfrm>
            <a:off x="204959" y="6234753"/>
            <a:ext cx="10825714" cy="4616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Arial"/>
              </a:rPr>
              <a:t>Supplemental Figure 5: Hazard ratio for primary outcome according to LSA</a:t>
            </a:r>
          </a:p>
          <a:p>
            <a:pPr lvl="0"/>
            <a:r>
              <a:rPr lang="en-US" sz="1200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: Life-Space Assessment</a:t>
            </a:r>
            <a:endParaRPr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F0909F5A-B361-0246-D4A5-6FF73305E1C1}"/>
              </a:ext>
            </a:extLst>
          </p:cNvPr>
          <p:cNvSpPr/>
          <p:nvPr/>
        </p:nvSpPr>
        <p:spPr>
          <a:xfrm>
            <a:off x="8607498" y="5065986"/>
            <a:ext cx="1051509" cy="16816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B2261BA7-7742-73C3-93CA-FA0D098F12F3}"/>
              </a:ext>
            </a:extLst>
          </p:cNvPr>
          <p:cNvSpPr/>
          <p:nvPr/>
        </p:nvSpPr>
        <p:spPr>
          <a:xfrm>
            <a:off x="8755117" y="5234152"/>
            <a:ext cx="662152" cy="7041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9D5DF09-1BC7-5236-B6CD-81E0AEBC7195}"/>
              </a:ext>
            </a:extLst>
          </p:cNvPr>
          <p:cNvSpPr txBox="1"/>
          <p:nvPr/>
        </p:nvSpPr>
        <p:spPr>
          <a:xfrm>
            <a:off x="8489514" y="4750511"/>
            <a:ext cx="555250" cy="20916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 descr="A graph with a line and a red line&#10;&#10;AI-generated content may be incorrect.">
            <a:extLst>
              <a:ext uri="{FF2B5EF4-FFF2-40B4-BE49-F238E27FC236}">
                <a16:creationId xmlns:a16="http://schemas.microsoft.com/office/drawing/2014/main" id="{88819624-CAD0-35B1-E88B-56BEADA2F80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61327" y="484583"/>
            <a:ext cx="9583616" cy="575017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71742810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5B4E95A-8138-4AD4-0690-BD90CA06377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Google Shape;121;p3">
            <a:extLst>
              <a:ext uri="{FF2B5EF4-FFF2-40B4-BE49-F238E27FC236}">
                <a16:creationId xmlns:a16="http://schemas.microsoft.com/office/drawing/2014/main" id="{F9678E67-E5A1-06A7-E44D-FBF7D0DE427F}"/>
              </a:ext>
            </a:extLst>
          </p:cNvPr>
          <p:cNvSpPr txBox="1"/>
          <p:nvPr/>
        </p:nvSpPr>
        <p:spPr>
          <a:xfrm>
            <a:off x="204959" y="6234753"/>
            <a:ext cx="10825714" cy="4616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Arial"/>
              </a:rPr>
              <a:t>Supplemental Figure 5: Hazard ratio for primary outcome according to simplified LSA</a:t>
            </a:r>
          </a:p>
          <a:p>
            <a:pPr lvl="0"/>
            <a:r>
              <a:rPr lang="en-US" sz="1200" dirty="0">
                <a:solidFill>
                  <a:schemeClr val="dk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: Life-Space Assessment</a:t>
            </a:r>
            <a:endParaRPr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0C78BBA5-ABD1-BD84-18EB-039C9048F532}"/>
              </a:ext>
            </a:extLst>
          </p:cNvPr>
          <p:cNvSpPr/>
          <p:nvPr/>
        </p:nvSpPr>
        <p:spPr>
          <a:xfrm>
            <a:off x="8607498" y="5065986"/>
            <a:ext cx="1051509" cy="16816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C32C6529-87AB-B9E9-BE9E-82580D8BA990}"/>
              </a:ext>
            </a:extLst>
          </p:cNvPr>
          <p:cNvSpPr/>
          <p:nvPr/>
        </p:nvSpPr>
        <p:spPr>
          <a:xfrm>
            <a:off x="8755117" y="5234152"/>
            <a:ext cx="662152" cy="7041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072CA78-EF73-62A0-40EA-951B93E22A8F}"/>
              </a:ext>
            </a:extLst>
          </p:cNvPr>
          <p:cNvSpPr txBox="1"/>
          <p:nvPr/>
        </p:nvSpPr>
        <p:spPr>
          <a:xfrm>
            <a:off x="8489514" y="4750511"/>
            <a:ext cx="555250" cy="20916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 descr="A graph with a line and a red line&#10;&#10;AI-generated content may be incorrect.">
            <a:extLst>
              <a:ext uri="{FF2B5EF4-FFF2-40B4-BE49-F238E27FC236}">
                <a16:creationId xmlns:a16="http://schemas.microsoft.com/office/drawing/2014/main" id="{194953BD-693D-912B-3ECF-50ED308B826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61327" y="484583"/>
            <a:ext cx="9583616" cy="5750170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Picture 2" descr="A graph with blue lines and red text&#10;&#10;AI-generated content may be incorrect.">
            <a:extLst>
              <a:ext uri="{FF2B5EF4-FFF2-40B4-BE49-F238E27FC236}">
                <a16:creationId xmlns:a16="http://schemas.microsoft.com/office/drawing/2014/main" id="{55992AD9-7391-9057-D5C7-C59974F8B235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2661" y="484582"/>
            <a:ext cx="9583615" cy="5750169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1734095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0629</TotalTime>
  <Words>145</Words>
  <Application>Microsoft Macintosh PowerPoint</Application>
  <PresentationFormat>Widescreen</PresentationFormat>
  <Paragraphs>20</Paragraphs>
  <Slides>6</Slides>
  <Notes>6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Times New Roman</vt:lpstr>
      <vt:lpstr>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LSA Figures_June25PG</dc:title>
  <dc:creator>Dylan Marshall</dc:creator>
  <cp:lastModifiedBy>Parag Goyal</cp:lastModifiedBy>
  <cp:revision>37</cp:revision>
  <dcterms:created xsi:type="dcterms:W3CDTF">2024-07-25T15:12:24Z</dcterms:created>
  <dcterms:modified xsi:type="dcterms:W3CDTF">2025-12-09T20:31:45Z</dcterms:modified>
</cp:coreProperties>
</file>